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86" autoAdjust="0"/>
    <p:restoredTop sz="93950" autoAdjust="0"/>
  </p:normalViewPr>
  <p:slideViewPr>
    <p:cSldViewPr snapToGrid="0">
      <p:cViewPr varScale="1">
        <p:scale>
          <a:sx n="83" d="100"/>
          <a:sy n="83" d="100"/>
        </p:scale>
        <p:origin x="3941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48A6B6-56A1-4B94-85F0-DDBF4D354F7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572125-22A1-4025-9B77-186FE76814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148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89E46-927A-4233-82C1-F7B5A138B465}" type="datetimeFigureOut">
              <a:rPr lang="zh-CN" altLang="en-US" smtClean="0"/>
              <a:t>2022/3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023C1-6045-44B5-9A4B-03F3F4E64BA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878" y="232818"/>
            <a:ext cx="6598884" cy="2772000"/>
          </a:xfrm>
          <a:prstGeom prst="rect">
            <a:avLst/>
          </a:prstGeom>
        </p:spPr>
      </p:pic>
      <p:sp>
        <p:nvSpPr>
          <p:cNvPr id="1339" name="文本框 1338"/>
          <p:cNvSpPr txBox="1"/>
          <p:nvPr/>
        </p:nvSpPr>
        <p:spPr>
          <a:xfrm>
            <a:off x="271411" y="1184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0" name="文本框 1339"/>
          <p:cNvSpPr txBox="1"/>
          <p:nvPr/>
        </p:nvSpPr>
        <p:spPr>
          <a:xfrm>
            <a:off x="1421627" y="313622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2" name="文本框 1341"/>
          <p:cNvSpPr txBox="1"/>
          <p:nvPr/>
        </p:nvSpPr>
        <p:spPr>
          <a:xfrm>
            <a:off x="1421627" y="602864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对象 1"/>
          <p:cNvGraphicFramePr>
            <a:graphicFrameLocks noChangeAspect="1"/>
          </p:cNvGraphicFramePr>
          <p:nvPr/>
        </p:nvGraphicFramePr>
        <p:xfrm>
          <a:off x="1707809" y="3032537"/>
          <a:ext cx="3779837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46" name="Prism 8" r:id="rId4" imgW="3787140" imgH="2903220" progId="Prism8.Document">
                  <p:embed/>
                </p:oleObj>
              </mc:Choice>
              <mc:Fallback>
                <p:oleObj name="Prism 8" r:id="rId4" imgW="3787140" imgH="2903220" progId="Prism8.Document">
                  <p:embed/>
                  <p:pic>
                    <p:nvPicPr>
                      <p:cNvPr id="0" name="图片 404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07809" y="3032537"/>
                        <a:ext cx="3779837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1707809" y="5944068"/>
          <a:ext cx="3781425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47" name="Prism 8" r:id="rId6" imgW="3787140" imgH="2903220" progId="Prism8.Document">
                  <p:embed/>
                </p:oleObj>
              </mc:Choice>
              <mc:Fallback>
                <p:oleObj name="Prism 8" r:id="rId6" imgW="3787140" imgH="2903220" progId="Prism8.Document">
                  <p:embed/>
                  <p:pic>
                    <p:nvPicPr>
                      <p:cNvPr id="0" name="图片 404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07809" y="5944068"/>
                        <a:ext cx="3781425" cy="2892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文本框 11"/>
          <p:cNvSpPr txBox="1"/>
          <p:nvPr/>
        </p:nvSpPr>
        <p:spPr>
          <a:xfrm>
            <a:off x="133350" y="8855710"/>
            <a:ext cx="7827010" cy="7067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 S1.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 Elevated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14-3-3ζ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 is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</a:rPr>
              <a:t>not 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associated with poor prognosis.</a:t>
            </a:r>
          </a:p>
          <a:p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A The expression of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  <a:sym typeface="+mn-ea"/>
              </a:rPr>
              <a:t>14-3-3ζ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 in cancer tissues in TMA, expression in adjacent normal tissues, and H &amp;E staining.</a:t>
            </a:r>
          </a:p>
          <a:p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B The relationship between overall survival and expression of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  <a:sym typeface="+mn-ea"/>
              </a:rPr>
              <a:t>14-3-3ζ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 was analyzed by Kaplan–Meier analysis.</a:t>
            </a:r>
          </a:p>
          <a:p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C The relation between disease-free survival and expression of </a:t>
            </a:r>
            <a:r>
              <a:rPr lang="en-US" altLang="zh-CN" sz="1000">
                <a:latin typeface="Times New Roman" panose="02020603050405020304" charset="0"/>
                <a:cs typeface="Times New Roman" panose="02020603050405020304" charset="0"/>
                <a:sym typeface="+mn-ea"/>
              </a:rPr>
              <a:t>14-3-3ζ</a:t>
            </a:r>
            <a:r>
              <a:rPr lang="zh-CN" altLang="en-US" sz="1000">
                <a:latin typeface="Times New Roman" panose="02020603050405020304" charset="0"/>
                <a:cs typeface="Times New Roman" panose="02020603050405020304" charset="0"/>
              </a:rPr>
              <a:t> was analyzed by Kaplan–Meier analysi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6</Words>
  <Application>Microsoft Office PowerPoint</Application>
  <PresentationFormat>A4 纸张(210x297 毫米)</PresentationFormat>
  <Paragraphs>7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rism 8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KSR2 AND 14-3-3</dc:title>
  <dc:creator>高 超</dc:creator>
  <cp:lastModifiedBy>Microsoft 帐户</cp:lastModifiedBy>
  <cp:revision>306</cp:revision>
  <dcterms:created xsi:type="dcterms:W3CDTF">2021-09-16T06:20:00Z</dcterms:created>
  <dcterms:modified xsi:type="dcterms:W3CDTF">2022-03-15T22:06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60FB32F2F945D1B12B9336F6F3C0AE</vt:lpwstr>
  </property>
  <property fmtid="{D5CDD505-2E9C-101B-9397-08002B2CF9AE}" pid="3" name="KSOProductBuildVer">
    <vt:lpwstr>2052-11.1.0.11294</vt:lpwstr>
  </property>
</Properties>
</file>